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75" r:id="rId3"/>
    <p:sldId id="263" r:id="rId4"/>
    <p:sldId id="257" r:id="rId5"/>
    <p:sldId id="265" r:id="rId6"/>
    <p:sldId id="258" r:id="rId7"/>
    <p:sldId id="264" r:id="rId8"/>
    <p:sldId id="271" r:id="rId9"/>
    <p:sldId id="276" r:id="rId10"/>
    <p:sldId id="273" r:id="rId11"/>
    <p:sldId id="274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423"/>
    <p:restoredTop sz="96405"/>
  </p:normalViewPr>
  <p:slideViewPr>
    <p:cSldViewPr snapToGrid="0">
      <p:cViewPr varScale="1">
        <p:scale>
          <a:sx n="128" d="100"/>
          <a:sy n="128" d="100"/>
        </p:scale>
        <p:origin x="4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F831D1-2A3B-0A10-5405-7419BE19E2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40D59A-C253-9303-AC92-3E7A807077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A53637-C476-D18C-DF1F-004BC2410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B51591-4380-68F7-6FCF-6DBA28927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937638-319A-899F-9D66-B5E3DD254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962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817B8-06F8-4389-63CC-6D1470591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AA587F-2030-2F62-FE27-E6302615BE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7E6873-C6C2-A202-7050-5A78CD316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62908-FE42-B585-1EBB-681E108D8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753802-70D2-7C20-104E-073F48CE9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46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44E35C8-0CAF-F452-FB7F-1B2EC62D51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1E07EC-28F6-8229-AEB2-C1C606500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3E6091-DCA3-2C19-0270-44BC0F067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DD8F0-4AA5-E7D8-3382-66D21C8F8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3A4BBC-F470-28FA-2C9E-B6C57FB4E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386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788E4-124F-940C-106F-12FFFD174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DB2FDD-6A4F-ECE3-6536-B6B8E43A40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8BA070-03D1-9613-C037-B4AA0F591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C2D4CF-539F-2B3B-E9D9-6A0EF23DA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5DBFEB-B793-6C34-9A7E-5DBD6FE45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363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270210-89CA-298E-09E2-D9F173CF4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74B067-4CAC-051C-11F6-ABAE93B8A8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DF0269-8459-19D5-EC6D-09372064C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906F73-69AE-A262-2F69-DDB141C08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F3116-1587-0582-370B-36A351CB11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052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9372CD-BA43-3302-3E15-2549C11852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6CC56D-11A1-0F43-779C-69363B4F70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CC1C2E-E858-441A-29DB-8A47C838D2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034ACF-F173-BDA0-D0CF-F41179BB1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DC53B4-A9B7-6322-84D7-5E7127724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18622B-335C-743B-5717-F227C6B48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076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F2BF7-4475-3205-BDF9-EB6390B514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4B7ED2-0B4C-6DF7-E946-4231218B2F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FFD6FC-BE15-B479-4472-8E24238A1C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FAD7F9B-F278-297F-16DC-EE5D3E8002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587ABC-1860-4464-0E8C-4A0A74DFA1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100ADE-C244-7B7B-7FAB-9F51BE34C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49ACAF-D17A-FFE7-FCDD-213EFBF4D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5FA70C-3010-50EF-56F1-78411DB12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327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F01B35-CDA4-26A3-536E-14D5693E59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21579D-F1C8-7093-29F7-E9FD9622C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5F66DE-2E2F-60D6-0E6C-638F3A0DD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C6D647-4E01-39CD-03DB-0FC35CA10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519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D4AE36-4EEF-4BCC-A8E9-F00FA7630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680561-E788-D800-6D7A-B1D84DD35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B71647-47F3-6433-0602-9F659BB37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543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06C7F-536D-341D-3F34-5BA1B655DC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841B6B-1F21-A2A3-9183-EE620C3C99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272400-2222-F5A5-2202-5D0ADB01C0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113A76-1507-2908-FCDD-7336DAB9C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2273C7-23C4-CE13-4CFE-2720520DC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14A7C8-62A8-2129-EA1F-F41E29641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52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CB8AE4-5D3F-294B-0499-700CDCB90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98D15C9-2870-7D30-2C0C-DB28851B8A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C9D8B3-D6F2-7D0F-FC7F-4D47C777AA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AC23C4-FB43-CB48-5D38-CA666F416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A3ECA7-7BF4-6DE3-3CB8-D69EAF3AA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62BB9F-2187-0039-7DF6-A32876DA5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107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DC5D6FC-40DC-B7B7-6E33-264659823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2466F5-719C-347D-E016-43346E2A18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62EC3B-E30D-B074-6D58-353961F5B7F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EA7A6-9239-D548-A641-4084E962E079}" type="datetimeFigureOut">
              <a:rPr lang="en-US" smtClean="0"/>
              <a:t>9/1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025FD4-E231-9460-C095-A61B301F79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2ACF14-A8A3-D7BB-1118-5BE2A3FE0E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AC09F-6227-8042-9099-686723DE1F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844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grossber@ohsu.edu" TargetMode="External"/><Relationship Id="rId2" Type="http://schemas.openxmlformats.org/officeDocument/2006/relationships/hyperlink" Target="mailto:marksd@ohsu.edu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emf"/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2.emf"/><Relationship Id="rId4" Type="http://schemas.openxmlformats.org/officeDocument/2006/relationships/image" Target="../media/image41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Relationship Id="rId9" Type="http://schemas.openxmlformats.org/officeDocument/2006/relationships/image" Target="../media/image20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emf"/><Relationship Id="rId5" Type="http://schemas.openxmlformats.org/officeDocument/2006/relationships/image" Target="../media/image37.emf"/><Relationship Id="rId4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AF6E28D-8F19-92EF-F265-D730723AFBBA}"/>
              </a:ext>
            </a:extLst>
          </p:cNvPr>
          <p:cNvSpPr txBox="1"/>
          <p:nvPr/>
        </p:nvSpPr>
        <p:spPr>
          <a:xfrm>
            <a:off x="318135" y="502402"/>
            <a:ext cx="11555730" cy="46166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Melanocortin-4 receptor antagonist TCMCB07alleviates chemotherapy-induced anorexia and weight loss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Xinxia Zhu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2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Russell Potterfield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Kenneth A. Gruber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,4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Emma Zhang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Samuel Newton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Mason A. Norgard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Peter R. Levasseur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2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eng Bai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5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Xu Chen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6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n-US" sz="1400" b="1" kern="100" dirty="0" err="1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Qingyang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Gu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6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Aaron J. Grossberg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,7,8*</a:t>
            </a: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Daniel L. Marks</a:t>
            </a:r>
            <a:r>
              <a:rPr lang="en-US" sz="1400" b="1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*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Papé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Family Pediatric Research Institute, Oregon Health &amp; Science University, Portland, Oregon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 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renden-Colson Center for Pancreatic Care, Oregon Health &amp; Science University, Portland, Oregon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Endevica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Bio, Northbrook, Illinois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4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Department of Medical Pharmacology &amp; Physiology and the Dalton Cardiovascular Research Center, University of Missouri, Columbia, Missouri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5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In Vivo Pharmacology Unit,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uXi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App Tec, Nantong, Jiangsu, Chin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6 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In Vivo Pharmacology Unit,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WuXi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App Tec, Shanghai, Chin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7 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epartment of Radiation Medicine, Oregon Health &amp; Science University, Portland, Oregon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baseline="300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8 </a:t>
            </a: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Cancer Early Detection Advanced Research Center, Oregon Health &amp; Science University, Portland, Oregon, USA.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 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Arial" panose="020B0604020202020204" pitchFamily="34" charset="0"/>
                <a:ea typeface="Arial Unicode MS" panose="020B0604020202020204" pitchFamily="34" charset="-128"/>
              </a:rPr>
              <a:t>*Correspondence: </a:t>
            </a:r>
            <a:r>
              <a:rPr lang="en-US" sz="1200" u="sng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  <a:hlinkClick r:id="rId2"/>
              </a:rPr>
              <a:t>dan@endevicabio.com</a:t>
            </a:r>
            <a:r>
              <a:rPr lang="en-US" sz="1200" u="sng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</a:rPr>
              <a:t> </a:t>
            </a:r>
            <a:r>
              <a:rPr lang="en-US" sz="120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</a:rPr>
              <a:t>and</a:t>
            </a:r>
            <a:r>
              <a:rPr lang="en-US" sz="1200" u="none" strike="noStrike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</a:rPr>
              <a:t> </a:t>
            </a:r>
            <a:r>
              <a:rPr lang="en-US" sz="1200" u="sng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Arial Unicode MS" panose="020B0604020202020204" pitchFamily="34" charset="-128"/>
                <a:cs typeface="Times New Roman" panose="02020603050405020304" pitchFamily="18" charset="0"/>
                <a:hlinkClick r:id="rId3"/>
              </a:rPr>
              <a:t>grossber@ohsu.edu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0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914063" y="125630"/>
            <a:ext cx="92765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. Related to Table 1. TCMCB07 is detectable in the circulation without</a:t>
            </a: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causing adverse effect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8DA8166-5F1E-26CC-3105-32AB96E1F0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5443" y="889441"/>
            <a:ext cx="3708704" cy="272698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8C8DF9A-7A5D-2697-F6AA-7EAE7205EF0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66228" y="857535"/>
            <a:ext cx="3912874" cy="279079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CBCBE0D-847D-8810-7188-DFBD693B2A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5442" y="3849965"/>
            <a:ext cx="3708705" cy="289969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55710E5-A5BE-A99E-DFC2-4C67DDDFA262}"/>
              </a:ext>
            </a:extLst>
          </p:cNvPr>
          <p:cNvSpPr txBox="1"/>
          <p:nvPr/>
        </p:nvSpPr>
        <p:spPr>
          <a:xfrm>
            <a:off x="914064" y="6626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A4F7DF-FDAD-9571-1A13-2722591E60E7}"/>
              </a:ext>
            </a:extLst>
          </p:cNvPr>
          <p:cNvSpPr txBox="1"/>
          <p:nvPr/>
        </p:nvSpPr>
        <p:spPr>
          <a:xfrm>
            <a:off x="6029361" y="6626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AAAF9DB-5389-49B4-1D1F-085839C382B2}"/>
              </a:ext>
            </a:extLst>
          </p:cNvPr>
          <p:cNvSpPr txBox="1"/>
          <p:nvPr/>
        </p:nvSpPr>
        <p:spPr>
          <a:xfrm>
            <a:off x="914064" y="357288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D963DB-1845-CF73-473A-687C080A3E8D}"/>
              </a:ext>
            </a:extLst>
          </p:cNvPr>
          <p:cNvSpPr txBox="1"/>
          <p:nvPr/>
        </p:nvSpPr>
        <p:spPr>
          <a:xfrm>
            <a:off x="6029548" y="3572885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097C442-E516-B51E-1451-CFD72569E3A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66228" y="3849965"/>
            <a:ext cx="3848360" cy="29369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65978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914064" y="193362"/>
            <a:ext cx="970941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. Related to Table 1. TCMCB07 is detectable in the circulation without </a:t>
            </a: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causing adverse effec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5710E5-A5BE-A99E-DFC2-4C67DDDFA262}"/>
              </a:ext>
            </a:extLst>
          </p:cNvPr>
          <p:cNvSpPr txBox="1"/>
          <p:nvPr/>
        </p:nvSpPr>
        <p:spPr>
          <a:xfrm>
            <a:off x="914064" y="85499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D8E6D03-A323-A179-0954-E8E97DDE263C}"/>
              </a:ext>
            </a:extLst>
          </p:cNvPr>
          <p:cNvSpPr txBox="1"/>
          <p:nvPr/>
        </p:nvSpPr>
        <p:spPr>
          <a:xfrm>
            <a:off x="914064" y="4348314"/>
            <a:ext cx="9894349" cy="13305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l Figure 6. Related to Table 1</a:t>
            </a: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eukocyte counts in rat blood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ollected from experiments of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Cisplatin/TCMCB07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5-FU/TCMCB07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Cyclophosphamide/TCMCB07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Vincristine/TCMCB07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E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Combination therapy of cisplatin+TCMCB07+GDF15 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antibody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F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Irinotecan and 5-FU combination chemotherapy and TCMCB07 treatment in 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rats with Ward colorectal tumor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ll data 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F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re expressed with each dot representing one sample.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=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8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12. 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5; *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1; **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01; ***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001, One-way ANOVA.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100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BB983A6-21F6-74C5-10DC-4B97F48D4A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064" y="1224328"/>
            <a:ext cx="5487806" cy="29469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6DB8F6F-6E6C-6828-1B2F-296AD845302C}"/>
              </a:ext>
            </a:extLst>
          </p:cNvPr>
          <p:cNvSpPr txBox="1"/>
          <p:nvPr/>
        </p:nvSpPr>
        <p:spPr>
          <a:xfrm>
            <a:off x="6729573" y="85499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41BEB3F-F641-4671-EF09-D985D614E4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9573" y="1216636"/>
            <a:ext cx="4078840" cy="2954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5105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302624" y="183429"/>
            <a:ext cx="9498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Related to Figure 1. </a:t>
            </a:r>
            <a:r>
              <a:rPr lang="en-US" sz="16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chematic of TCMCB07/chemotherapy study design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8ABC7F-818B-36F2-4140-CC97299A24BA}"/>
              </a:ext>
            </a:extLst>
          </p:cNvPr>
          <p:cNvSpPr txBox="1"/>
          <p:nvPr/>
        </p:nvSpPr>
        <p:spPr>
          <a:xfrm>
            <a:off x="302625" y="7389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3AEE49-F6FD-E9CE-2BE4-43016F5FED44}"/>
              </a:ext>
            </a:extLst>
          </p:cNvPr>
          <p:cNvSpPr txBox="1"/>
          <p:nvPr/>
        </p:nvSpPr>
        <p:spPr>
          <a:xfrm>
            <a:off x="6089995" y="7389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AC231C7-5CE9-CBAB-7A9D-D8566E0056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624" y="3932066"/>
            <a:ext cx="5715000" cy="241962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7DBA80B-06FB-F01C-287C-824C6875DB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625" y="1085511"/>
            <a:ext cx="5715000" cy="240631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ACCF0A2-3439-CE0A-3340-69729E0EA8E8}"/>
              </a:ext>
            </a:extLst>
          </p:cNvPr>
          <p:cNvSpPr txBox="1"/>
          <p:nvPr/>
        </p:nvSpPr>
        <p:spPr>
          <a:xfrm>
            <a:off x="6428549" y="4001428"/>
            <a:ext cx="4986040" cy="23502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1. Related to Figure 1</a:t>
            </a:r>
          </a:p>
          <a:p>
            <a:pPr algn="just">
              <a:lnSpc>
                <a:spcPct val="150000"/>
              </a:lnSpc>
            </a:pP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hemotherapy dosing regimen selection. 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A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 Daily food intake, 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B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 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ily body weight, and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Daily body weight gain (% initial body weight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,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following each cycle of chemotherapy with cisplatin administered at doses of 2.5 or 5 mg/kg, or with 5-FU at doses of 62.5 or 125 mg/kg. During the third cycle of chemotherapy, high-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dose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isplatin or 5-FU was discontinued due to 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mortality or severe deterioration in condition. T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he low dose of cisplatin was adjusted from 2.5 to 3 mg/kg, and the low dose of 5-FU was adjusted from 62.5 to 80 mg/kg. </a:t>
            </a:r>
            <a:r>
              <a:rPr lang="en-US" sz="1100" i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n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= 4.</a:t>
            </a:r>
            <a:endParaRPr lang="en-US" sz="11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A1FD155-4FCF-E437-11DA-20149CD8CFF0}"/>
              </a:ext>
            </a:extLst>
          </p:cNvPr>
          <p:cNvSpPr txBox="1"/>
          <p:nvPr/>
        </p:nvSpPr>
        <p:spPr>
          <a:xfrm>
            <a:off x="302624" y="356273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DF4FBF7-E031-DEBB-40A9-C56432E42EC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085512"/>
            <a:ext cx="5833494" cy="24063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5936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/>
      <p:bldP spid="10" grpId="0"/>
      <p:bldP spid="2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306205" y="123205"/>
            <a:ext cx="94850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Related to Figure 1. </a:t>
            </a:r>
            <a:r>
              <a:rPr lang="en-US" sz="1600" b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chematic of TCMCB07/chemotherapy study design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8ABC7F-818B-36F2-4140-CC97299A24BA}"/>
              </a:ext>
            </a:extLst>
          </p:cNvPr>
          <p:cNvSpPr txBox="1"/>
          <p:nvPr/>
        </p:nvSpPr>
        <p:spPr>
          <a:xfrm>
            <a:off x="430569" y="4498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3AEE49-F6FD-E9CE-2BE4-43016F5FED44}"/>
              </a:ext>
            </a:extLst>
          </p:cNvPr>
          <p:cNvSpPr txBox="1"/>
          <p:nvPr/>
        </p:nvSpPr>
        <p:spPr>
          <a:xfrm>
            <a:off x="6207035" y="4498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B193966-E7A0-9BBC-BB3C-642E9CB214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33163" y="796455"/>
            <a:ext cx="5369338" cy="256794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E926440-8766-B62B-EAC5-E9ADA251CC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697" y="3674558"/>
            <a:ext cx="5676718" cy="244760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9CAA4F0-87A5-1557-EA15-8E29B96A4AF9}"/>
              </a:ext>
            </a:extLst>
          </p:cNvPr>
          <p:cNvSpPr txBox="1"/>
          <p:nvPr/>
        </p:nvSpPr>
        <p:spPr>
          <a:xfrm>
            <a:off x="430569" y="330522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673FB47-21EC-C60B-9C69-FADC95DA31D6}"/>
              </a:ext>
            </a:extLst>
          </p:cNvPr>
          <p:cNvSpPr txBox="1"/>
          <p:nvPr/>
        </p:nvSpPr>
        <p:spPr>
          <a:xfrm>
            <a:off x="6233163" y="3305226"/>
            <a:ext cx="3257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833677E-FC78-214B-FC25-9CF2274591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7035" y="3674557"/>
            <a:ext cx="5622635" cy="244760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D0F1C76-6A7A-2E45-6E9A-7494ED1980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6697" y="815349"/>
            <a:ext cx="5369339" cy="255512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E258E33-D8B2-38FA-CD4C-850C22C674D4}"/>
              </a:ext>
            </a:extLst>
          </p:cNvPr>
          <p:cNvSpPr txBox="1"/>
          <p:nvPr/>
        </p:nvSpPr>
        <p:spPr>
          <a:xfrm>
            <a:off x="306205" y="6140993"/>
            <a:ext cx="11296298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Supplemental Figure 1. Related to Figure 1</a:t>
            </a:r>
          </a:p>
          <a:p>
            <a:pPr algn="just"/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hemotherapy dosing 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regimen selection. 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D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 and 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F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 Daily body weight,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nd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E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and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G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 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aily body weight gain (% initial body weight</a:t>
            </a:r>
            <a:r>
              <a:rPr lang="en-US" sz="1100" dirty="0">
                <a:latin typeface="Arial" panose="020B0604020202020204" pitchFamily="34" charset="0"/>
                <a:ea typeface="DengXian" panose="02010600030101010101" pitchFamily="2" charset="-122"/>
              </a:rPr>
              <a:t>),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following each cycle of chemotherapy with cyclophosphamide administered at doses of 50, 70, 90 or 110 mg/kg, or with vincristine at doses of 0.18, 0.25, 0.30, or 0.40 mg/kg. </a:t>
            </a:r>
            <a:r>
              <a:rPr lang="en-US" sz="1100" i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n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= 4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7998888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8" grpId="0"/>
      <p:bldP spid="10" grpId="0"/>
      <p:bldP spid="5" grpId="0"/>
      <p:bldP spid="6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757623" y="142724"/>
            <a:ext cx="103241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Related to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CMCB07 treatment preserves body mass throughout multiple cycles of chemotherapy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F73B335-9D75-1E7F-1F98-2C69A0BA6CE1}"/>
              </a:ext>
            </a:extLst>
          </p:cNvPr>
          <p:cNvSpPr txBox="1"/>
          <p:nvPr/>
        </p:nvSpPr>
        <p:spPr>
          <a:xfrm>
            <a:off x="6326130" y="8058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8ABC7F-818B-36F2-4140-CC97299A24BA}"/>
              </a:ext>
            </a:extLst>
          </p:cNvPr>
          <p:cNvSpPr txBox="1"/>
          <p:nvPr/>
        </p:nvSpPr>
        <p:spPr>
          <a:xfrm>
            <a:off x="766493" y="80586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F29B0B2-1E92-5189-332A-ACAF8EC19558}"/>
              </a:ext>
            </a:extLst>
          </p:cNvPr>
          <p:cNvSpPr txBox="1"/>
          <p:nvPr/>
        </p:nvSpPr>
        <p:spPr>
          <a:xfrm>
            <a:off x="757623" y="359011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E923460-FBD5-5EEE-74D7-DA6354E1AE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7623" y="1164152"/>
            <a:ext cx="4809309" cy="22692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670EA2A-7876-4DE9-D983-79D035CA88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6129" y="1164152"/>
            <a:ext cx="4755651" cy="226923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BFEFC1F-0567-4AFE-941F-4C02DC38ADE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6493" y="3975109"/>
            <a:ext cx="4809309" cy="252063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6B92E56-C647-F9E8-5365-A114AF46F1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6129" y="3975109"/>
            <a:ext cx="5251320" cy="252063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C04A9C30-C126-E446-B174-9C9C456F8AEA}"/>
              </a:ext>
            </a:extLst>
          </p:cNvPr>
          <p:cNvSpPr txBox="1"/>
          <p:nvPr/>
        </p:nvSpPr>
        <p:spPr>
          <a:xfrm>
            <a:off x="6326130" y="3579255"/>
            <a:ext cx="308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8058389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8" grpId="0"/>
      <p:bldP spid="5" grpId="0"/>
      <p:bldP spid="13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554382" y="130318"/>
            <a:ext cx="105876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Related to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CMCB07 treatment preserves body mass throughout multiple cycles of chemotherapy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31963D-97F7-D8E7-AA24-2A2DB6703D72}"/>
              </a:ext>
            </a:extLst>
          </p:cNvPr>
          <p:cNvSpPr txBox="1"/>
          <p:nvPr/>
        </p:nvSpPr>
        <p:spPr>
          <a:xfrm>
            <a:off x="791565" y="77472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643F0F76-1481-46A6-CF1C-203008C38D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565" y="1144059"/>
            <a:ext cx="4911077" cy="23816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EC70F93-AF5A-FF52-05B8-EC88854EA9EA}"/>
              </a:ext>
            </a:extLst>
          </p:cNvPr>
          <p:cNvSpPr txBox="1"/>
          <p:nvPr/>
        </p:nvSpPr>
        <p:spPr>
          <a:xfrm>
            <a:off x="791565" y="3692318"/>
            <a:ext cx="9030529" cy="15885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Figure 2. 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lated to Figure 3</a:t>
            </a:r>
          </a:p>
          <a:p>
            <a:pPr algn="just">
              <a:lnSpc>
                <a:spcPct val="150000"/>
              </a:lnSpc>
            </a:pP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CMCB07 treatment preserves body mass throughout multiple cycles of chemotherapy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aily body weight after  cisplat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5-FU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cyclophosphamide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vincristine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doxorubicin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chemotherapy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nd TCMCB07 treatment. All data 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E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are expressed as mean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SEM for each group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= 10-12. *: Chemotherapy/saline vs Chemotherapy/TCMCB07, #: Chemotherapy/saline vs Saline/saline, &amp;: Chemotherapy/TCMCB07 vs Saline/saline. *, #, &amp;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; **, ##, &amp;&amp;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1; ***, ###, &amp;&amp;&amp;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01; ****, ####, &amp;&amp;&amp;&amp;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001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wo-way ANOVA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9071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440495" y="169300"/>
            <a:ext cx="113110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Related to Figure 4. TCMCB07 treatment attenuates chemotherapy-induced tissue wasting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20C27B6-F747-120F-CC8F-0AEBFAEBE022}"/>
              </a:ext>
            </a:extLst>
          </p:cNvPr>
          <p:cNvSpPr txBox="1"/>
          <p:nvPr/>
        </p:nvSpPr>
        <p:spPr>
          <a:xfrm>
            <a:off x="1019003" y="349644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A084AD7-4F60-54AC-3DEE-E894B9EB79A9}"/>
              </a:ext>
            </a:extLst>
          </p:cNvPr>
          <p:cNvSpPr txBox="1"/>
          <p:nvPr/>
        </p:nvSpPr>
        <p:spPr>
          <a:xfrm rot="16200000">
            <a:off x="-420517" y="1977659"/>
            <a:ext cx="2055371" cy="30777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isplatin chemotherap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9893AF-0F09-E4D8-C598-AC6E803B25BB}"/>
              </a:ext>
            </a:extLst>
          </p:cNvPr>
          <p:cNvSpPr txBox="1"/>
          <p:nvPr/>
        </p:nvSpPr>
        <p:spPr>
          <a:xfrm>
            <a:off x="1009385" y="8509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469E82-CDDA-F718-8727-7E71AB186AB8}"/>
              </a:ext>
            </a:extLst>
          </p:cNvPr>
          <p:cNvSpPr txBox="1"/>
          <p:nvPr/>
        </p:nvSpPr>
        <p:spPr>
          <a:xfrm rot="16200000">
            <a:off x="-265159" y="4626046"/>
            <a:ext cx="1765227" cy="30777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-FU chemotherapy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72E8D7B8-62D2-82D8-7B06-BE7B070E3D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1386" y="1220242"/>
            <a:ext cx="3937401" cy="1822613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C2CA8115-96A9-4983-F76B-102D0643A3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19116" y="1224538"/>
            <a:ext cx="3397846" cy="1829021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1F784DBA-9C91-0818-D6DF-5DE4FC9B53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97402" y="1224538"/>
            <a:ext cx="1582064" cy="1829021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4417464F-44E6-DDA8-3631-13F8CFA27A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59906" y="1230945"/>
            <a:ext cx="1556816" cy="1822614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224D6EC6-496B-A3E4-D9B2-ECC32CA671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1386" y="3900303"/>
            <a:ext cx="3937401" cy="1762245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BC3023C-4F79-BAE2-1C33-9F9D33E816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19116" y="3833527"/>
            <a:ext cx="3397846" cy="1829021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FDC0AD50-FC29-DCB0-2AD4-2C652F45BAB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97402" y="3833528"/>
            <a:ext cx="1582064" cy="182902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2FD8E669-6801-8D53-8A5C-1DBE780FAA0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59906" y="3833527"/>
            <a:ext cx="1582064" cy="1829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33781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440495" y="169300"/>
            <a:ext cx="113110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Related to Figure 4. TCMCB07 treatment attenuates chemotherapy-induced tissue wasting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20C27B6-F747-120F-CC8F-0AEBFAEBE022}"/>
              </a:ext>
            </a:extLst>
          </p:cNvPr>
          <p:cNvSpPr txBox="1"/>
          <p:nvPr/>
        </p:nvSpPr>
        <p:spPr>
          <a:xfrm>
            <a:off x="1019003" y="34134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9893AF-0F09-E4D8-C598-AC6E803B25BB}"/>
              </a:ext>
            </a:extLst>
          </p:cNvPr>
          <p:cNvSpPr txBox="1"/>
          <p:nvPr/>
        </p:nvSpPr>
        <p:spPr>
          <a:xfrm>
            <a:off x="1009385" y="66206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A1CFC5-2D32-91C9-1D45-04B498BEF8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1386" y="1042104"/>
            <a:ext cx="3897179" cy="18318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B0D1A01-F058-4542-9E65-1E930BFE7A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8894" y="1040555"/>
            <a:ext cx="3301159" cy="182902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68BE196-9F42-BBF0-F0EF-49F6E84D73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97402" y="1019321"/>
            <a:ext cx="1556816" cy="186817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035EEA4-61E8-6F93-63D3-518D968E70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443130" y="1010888"/>
            <a:ext cx="1415616" cy="188504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12D2BC7-5F19-DCEB-F9B2-1150CB82C0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21386" y="3814356"/>
            <a:ext cx="3897179" cy="18023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96EEAA88-8C30-BE07-406B-A93D77849F8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68608" y="3804542"/>
            <a:ext cx="3301159" cy="182491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2AF0A0E-12DB-061E-4830-A7C5A84D921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92914" y="3512017"/>
            <a:ext cx="1561304" cy="210469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5DFCBFC-642C-391C-27EF-5C0022B5D8C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423044" y="3613135"/>
            <a:ext cx="1465903" cy="19621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6509433-0894-F0E1-68C6-625F5869E92A}"/>
              </a:ext>
            </a:extLst>
          </p:cNvPr>
          <p:cNvSpPr txBox="1"/>
          <p:nvPr/>
        </p:nvSpPr>
        <p:spPr>
          <a:xfrm>
            <a:off x="921386" y="5700893"/>
            <a:ext cx="10967561" cy="10806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l 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gure 3. Related to Figure 4</a:t>
            </a:r>
            <a:endParaRPr lang="en-US" sz="1100" b="1" kern="100" dirty="0">
              <a:latin typeface="Arial" panose="020B060402020202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TCMCB07 treatment attenuates chemotherapy-induced tissue wasting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at mass, lean mass, heart mass, and gastrocnemius mass after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isplatin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5-FU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cyclophosphamide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vincristine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,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nd TCMCB07 treatment. All data 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are expressed with each dot representing one sample.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n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= 10-12. *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; **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1; ***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01; ****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001, One-way ANOVA. 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D5CC5B8-2C9E-3368-4281-5A75E95908C0}"/>
              </a:ext>
            </a:extLst>
          </p:cNvPr>
          <p:cNvSpPr txBox="1"/>
          <p:nvPr/>
        </p:nvSpPr>
        <p:spPr>
          <a:xfrm rot="16200000">
            <a:off x="-812794" y="1903743"/>
            <a:ext cx="2890535" cy="30777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yclophosphamide chemotherap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1CABCE-AAEC-20FE-5197-4CC0E3B100A0}"/>
              </a:ext>
            </a:extLst>
          </p:cNvPr>
          <p:cNvSpPr txBox="1"/>
          <p:nvPr/>
        </p:nvSpPr>
        <p:spPr>
          <a:xfrm rot="16200000">
            <a:off x="-463307" y="4665617"/>
            <a:ext cx="2191562" cy="307777"/>
          </a:xfrm>
          <a:prstGeom prst="rect">
            <a:avLst/>
          </a:prstGeom>
          <a:solidFill>
            <a:schemeClr val="bg2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incristine chemotherapy</a:t>
            </a:r>
          </a:p>
        </p:txBody>
      </p:sp>
    </p:spTree>
    <p:extLst>
      <p:ext uri="{BB962C8B-B14F-4D97-AF65-F5344CB8AC3E}">
        <p14:creationId xmlns:p14="http://schemas.microsoft.com/office/powerpoint/2010/main" val="39949830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824307" y="215625"/>
            <a:ext cx="103310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Related to Figure 6. TCMCB07 + GDF15 antibody combination therapy enhances</a:t>
            </a: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effectiveness in maintaining body and tissue mass during chemotherapy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B6F965-95A6-6CF7-B77D-7A079009E218}"/>
              </a:ext>
            </a:extLst>
          </p:cNvPr>
          <p:cNvSpPr txBox="1"/>
          <p:nvPr/>
        </p:nvSpPr>
        <p:spPr>
          <a:xfrm>
            <a:off x="701020" y="89843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A4AB28C-9BEF-A317-8F6C-D3631BBBF1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020" y="1260666"/>
            <a:ext cx="6766764" cy="244658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8E10CCE-6407-9D1B-1A06-9FAD7A19E9F4}"/>
              </a:ext>
            </a:extLst>
          </p:cNvPr>
          <p:cNvSpPr txBox="1"/>
          <p:nvPr/>
        </p:nvSpPr>
        <p:spPr>
          <a:xfrm>
            <a:off x="701020" y="38169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A04121-0787-34CF-79A2-F7EBE8EE71B0}"/>
              </a:ext>
            </a:extLst>
          </p:cNvPr>
          <p:cNvSpPr txBox="1"/>
          <p:nvPr/>
        </p:nvSpPr>
        <p:spPr>
          <a:xfrm>
            <a:off x="7370410" y="3844987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976A00-742B-B8D1-F16C-B9B8770381C2}"/>
              </a:ext>
            </a:extLst>
          </p:cNvPr>
          <p:cNvSpPr txBox="1"/>
          <p:nvPr/>
        </p:nvSpPr>
        <p:spPr>
          <a:xfrm>
            <a:off x="4815570" y="381815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860836-A703-F305-6DEA-73C0B6CE5032}"/>
              </a:ext>
            </a:extLst>
          </p:cNvPr>
          <p:cNvSpPr txBox="1"/>
          <p:nvPr/>
        </p:nvSpPr>
        <p:spPr>
          <a:xfrm>
            <a:off x="9417884" y="381697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EE03BF-2226-7DBD-ECA9-26A6427F760B}"/>
              </a:ext>
            </a:extLst>
          </p:cNvPr>
          <p:cNvSpPr txBox="1"/>
          <p:nvPr/>
        </p:nvSpPr>
        <p:spPr>
          <a:xfrm>
            <a:off x="7553951" y="900254"/>
            <a:ext cx="4066419" cy="31079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l Figure 4. Related to Figure 6</a:t>
            </a: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CMCB07 + GDF15 antibody combination therapy enhances effectiveness in maintaining body and tissue mass during chemotherapy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aily body weight,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Fat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Lean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Heart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E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Gastrocnemius mass after treatment of </a:t>
            </a:r>
            <a:r>
              <a:rPr lang="en-US" sz="1100" dirty="0" err="1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isplatin+saline+IgG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, cisplatin+saline+GDF15 antibody (Ab), or cisplatin+TCMCB07+GDF15 Ab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ll data 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are expressed as mean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SEM for each group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ll data in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-E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re expressed with each dot representing one sample.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= 10-11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lt; 0.05;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**, ##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1; ***, ###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01; ****, ####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001, One-way ANOVA.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100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9C9ABB9-3974-6540-B00F-07092BE9F9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23783" y="4186308"/>
            <a:ext cx="1940728" cy="224367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9C61B32-8880-FFCF-07F1-9282EA51A7C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55533" y="4186308"/>
            <a:ext cx="1803735" cy="224367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DC8F1E3-507B-28CB-84DA-DADBA016ED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1020" y="4187489"/>
            <a:ext cx="4023528" cy="224248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77BDE42-BC1E-B0AA-0B26-EA7C3CA48D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39796" y="4186309"/>
            <a:ext cx="2492965" cy="2243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653954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C8CB14-28D9-5773-C26B-8EA261822D16}"/>
              </a:ext>
            </a:extLst>
          </p:cNvPr>
          <p:cNvSpPr txBox="1"/>
          <p:nvPr/>
        </p:nvSpPr>
        <p:spPr>
          <a:xfrm>
            <a:off x="824308" y="252107"/>
            <a:ext cx="103310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Related to Figure 7. TCMCB07 treatment mitigates anorexia and weight loss in</a:t>
            </a: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rats with Ward colorectal tumor following combination chemotherapy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7B6F965-95A6-6CF7-B77D-7A079009E218}"/>
              </a:ext>
            </a:extLst>
          </p:cNvPr>
          <p:cNvSpPr txBox="1"/>
          <p:nvPr/>
        </p:nvSpPr>
        <p:spPr>
          <a:xfrm>
            <a:off x="824308" y="89843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8E10CCE-6407-9D1B-1A06-9FAD7A19E9F4}"/>
              </a:ext>
            </a:extLst>
          </p:cNvPr>
          <p:cNvSpPr txBox="1"/>
          <p:nvPr/>
        </p:nvSpPr>
        <p:spPr>
          <a:xfrm>
            <a:off x="824308" y="398447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8A04121-0787-34CF-79A2-F7EBE8EE71B0}"/>
              </a:ext>
            </a:extLst>
          </p:cNvPr>
          <p:cNvSpPr txBox="1"/>
          <p:nvPr/>
        </p:nvSpPr>
        <p:spPr>
          <a:xfrm>
            <a:off x="7616979" y="3989957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976A00-742B-B8D1-F16C-B9B8770381C2}"/>
              </a:ext>
            </a:extLst>
          </p:cNvPr>
          <p:cNvSpPr txBox="1"/>
          <p:nvPr/>
        </p:nvSpPr>
        <p:spPr>
          <a:xfrm>
            <a:off x="4223645" y="398447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860836-A703-F305-6DEA-73C0B6CE5032}"/>
              </a:ext>
            </a:extLst>
          </p:cNvPr>
          <p:cNvSpPr txBox="1"/>
          <p:nvPr/>
        </p:nvSpPr>
        <p:spPr>
          <a:xfrm>
            <a:off x="9465783" y="398447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EE03BF-2226-7DBD-ECA9-26A6427F760B}"/>
              </a:ext>
            </a:extLst>
          </p:cNvPr>
          <p:cNvSpPr txBox="1"/>
          <p:nvPr/>
        </p:nvSpPr>
        <p:spPr>
          <a:xfrm>
            <a:off x="7397835" y="1106811"/>
            <a:ext cx="3969857" cy="26001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upplemental Figure 5. Related to Figure 7</a:t>
            </a: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CMCB07 treatment mitigates anorexia and weight loss in rats with Ward colorectal tumor following irinotecan and 5-FU combination chemotherapy.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aily body weight,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(</a:t>
            </a:r>
            <a:r>
              <a:rPr lang="en-US" sz="1100" b="1" dirty="0">
                <a:latin typeface="Arial" panose="020B0604020202020204" pitchFamily="34" charset="0"/>
                <a:ea typeface="DengXian" panose="02010600030101010101" pitchFamily="2" charset="-122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Fat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C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Lean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D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Heart mass, (</a:t>
            </a:r>
            <a:r>
              <a:rPr lang="en-US" sz="1100" b="1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E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) Gastrocnemius mass after combination chemotherapy of irinotecan and 5-FU  and TCMCB07 treatment.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ll data in (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) are expressed as mean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SEM for each group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 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ll data in (</a:t>
            </a:r>
            <a:r>
              <a:rPr lang="en-US" sz="1100" b="1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-E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re expressed with each dot representing one sample.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= 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8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12. *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1; ****, </a:t>
            </a:r>
            <a:r>
              <a:rPr lang="en-US" sz="1100" i="1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100" kern="1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&lt; 0.0001, One-way ANOVA.</a:t>
            </a:r>
            <a:r>
              <a:rPr lang="en-US" sz="1100" kern="1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100" kern="100" dirty="0">
              <a:effectLst/>
              <a:latin typeface="Arial" panose="020B060402020202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B0BD0EA-DA2E-7B3D-53D9-A348463056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8300" y="4620289"/>
            <a:ext cx="3344551" cy="178526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B760622-BDA9-35AB-2BD2-9560C00DFF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7506" y="4382996"/>
            <a:ext cx="1733622" cy="202255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4436FA7-84A3-D6E6-B4B9-676A36CD60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65783" y="4382996"/>
            <a:ext cx="1733622" cy="20140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4B4EED1-584C-A380-AB8F-A1F3F31068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4308" y="1215479"/>
            <a:ext cx="6485208" cy="272053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C4042EF-3964-BE61-C6BA-D1D316331EE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7822" y="4329029"/>
            <a:ext cx="3395823" cy="2076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2826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14</TotalTime>
  <Words>1250</Words>
  <Application>Microsoft Macintosh PowerPoint</Application>
  <PresentationFormat>Widescreen</PresentationFormat>
  <Paragraphs>79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nxia Zhu</dc:creator>
  <cp:lastModifiedBy>Xinxia Zhu</cp:lastModifiedBy>
  <cp:revision>344</cp:revision>
  <dcterms:created xsi:type="dcterms:W3CDTF">2023-10-02T21:23:27Z</dcterms:created>
  <dcterms:modified xsi:type="dcterms:W3CDTF">2024-09-14T23:25:31Z</dcterms:modified>
</cp:coreProperties>
</file>